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88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辰巳　めぐみ" userId="88b1893c-db63-4bb5-9dca-a6ce3447aab8" providerId="ADAL" clId="{4C98BF49-9253-44F8-8335-0E5DA0562794}"/>
    <pc:docChg chg="undo custSel modSld">
      <pc:chgData name="辰巳　めぐみ" userId="88b1893c-db63-4bb5-9dca-a6ce3447aab8" providerId="ADAL" clId="{4C98BF49-9253-44F8-8335-0E5DA0562794}" dt="2025-12-23T01:23:25.692" v="124" actId="478"/>
      <pc:docMkLst>
        <pc:docMk/>
      </pc:docMkLst>
      <pc:sldChg chg="addSp delSp modSp mod">
        <pc:chgData name="辰巳　めぐみ" userId="88b1893c-db63-4bb5-9dca-a6ce3447aab8" providerId="ADAL" clId="{4C98BF49-9253-44F8-8335-0E5DA0562794}" dt="2025-12-23T01:23:25.692" v="124" actId="478"/>
        <pc:sldMkLst>
          <pc:docMk/>
          <pc:sldMk cId="3285713202" sldId="256"/>
        </pc:sldMkLst>
        <pc:spChg chg="add del mod">
          <ac:chgData name="辰巳　めぐみ" userId="88b1893c-db63-4bb5-9dca-a6ce3447aab8" providerId="ADAL" clId="{4C98BF49-9253-44F8-8335-0E5DA0562794}" dt="2025-12-23T01:23:25.692" v="124" actId="478"/>
          <ac:spMkLst>
            <pc:docMk/>
            <pc:sldMk cId="3285713202" sldId="256"/>
            <ac:spMk id="2" creationId="{59C34CA8-6F1F-5CA1-422E-C0F3FCB73AB7}"/>
          </ac:spMkLst>
        </pc:spChg>
        <pc:spChg chg="add mod">
          <ac:chgData name="辰巳　めぐみ" userId="88b1893c-db63-4bb5-9dca-a6ce3447aab8" providerId="ADAL" clId="{4C98BF49-9253-44F8-8335-0E5DA0562794}" dt="2025-12-16T07:05:21.199" v="115"/>
          <ac:spMkLst>
            <pc:docMk/>
            <pc:sldMk cId="3285713202" sldId="256"/>
            <ac:spMk id="3" creationId="{AC121DDB-C507-4F57-DFDC-08DC60C2462F}"/>
          </ac:spMkLst>
        </pc:spChg>
        <pc:spChg chg="add mod">
          <ac:chgData name="辰巳　めぐみ" userId="88b1893c-db63-4bb5-9dca-a6ce3447aab8" providerId="ADAL" clId="{4C98BF49-9253-44F8-8335-0E5DA0562794}" dt="2025-12-16T07:05:21.199" v="115"/>
          <ac:spMkLst>
            <pc:docMk/>
            <pc:sldMk cId="3285713202" sldId="256"/>
            <ac:spMk id="4" creationId="{FB594275-5190-B4B8-A37A-E6394FAAD666}"/>
          </ac:spMkLst>
        </pc:spChg>
        <pc:spChg chg="mod">
          <ac:chgData name="辰巳　めぐみ" userId="88b1893c-db63-4bb5-9dca-a6ce3447aab8" providerId="ADAL" clId="{4C98BF49-9253-44F8-8335-0E5DA0562794}" dt="2025-12-16T05:45:07.877" v="89"/>
          <ac:spMkLst>
            <pc:docMk/>
            <pc:sldMk cId="3285713202" sldId="256"/>
            <ac:spMk id="5" creationId="{131A1956-03FD-E9AD-3AD1-02E5585409FB}"/>
          </ac:spMkLst>
        </pc:spChg>
        <pc:spChg chg="add mod">
          <ac:chgData name="辰巳　めぐみ" userId="88b1893c-db63-4bb5-9dca-a6ce3447aab8" providerId="ADAL" clId="{4C98BF49-9253-44F8-8335-0E5DA0562794}" dt="2025-12-16T07:05:21.199" v="115"/>
          <ac:spMkLst>
            <pc:docMk/>
            <pc:sldMk cId="3285713202" sldId="256"/>
            <ac:spMk id="6" creationId="{98340E8A-1173-F224-D5F1-4EE301DBD3A2}"/>
          </ac:spMkLst>
        </pc:spChg>
        <pc:spChg chg="add mod">
          <ac:chgData name="辰巳　めぐみ" userId="88b1893c-db63-4bb5-9dca-a6ce3447aab8" providerId="ADAL" clId="{4C98BF49-9253-44F8-8335-0E5DA0562794}" dt="2025-12-16T07:18:38.371" v="123"/>
          <ac:spMkLst>
            <pc:docMk/>
            <pc:sldMk cId="3285713202" sldId="256"/>
            <ac:spMk id="8" creationId="{235520D5-DABE-AB48-9A60-07C6A65DA240}"/>
          </ac:spMkLst>
        </pc:spChg>
        <pc:spChg chg="add mod">
          <ac:chgData name="辰巳　めぐみ" userId="88b1893c-db63-4bb5-9dca-a6ce3447aab8" providerId="ADAL" clId="{4C98BF49-9253-44F8-8335-0E5DA0562794}" dt="2025-12-16T07:18:38.371" v="123"/>
          <ac:spMkLst>
            <pc:docMk/>
            <pc:sldMk cId="3285713202" sldId="256"/>
            <ac:spMk id="9" creationId="{9896ECC6-4160-58EE-9664-2E6403709359}"/>
          </ac:spMkLst>
        </pc:spChg>
        <pc:spChg chg="add mod">
          <ac:chgData name="辰巳　めぐみ" userId="88b1893c-db63-4bb5-9dca-a6ce3447aab8" providerId="ADAL" clId="{4C98BF49-9253-44F8-8335-0E5DA0562794}" dt="2025-12-16T07:18:38.371" v="123"/>
          <ac:spMkLst>
            <pc:docMk/>
            <pc:sldMk cId="3285713202" sldId="256"/>
            <ac:spMk id="11" creationId="{706A334C-27D0-4C56-C285-18677DA4DE9F}"/>
          </ac:spMkLst>
        </pc:spChg>
        <pc:spChg chg="add mod">
          <ac:chgData name="辰巳　めぐみ" userId="88b1893c-db63-4bb5-9dca-a6ce3447aab8" providerId="ADAL" clId="{4C98BF49-9253-44F8-8335-0E5DA0562794}" dt="2025-12-16T07:18:38.371" v="123"/>
          <ac:spMkLst>
            <pc:docMk/>
            <pc:sldMk cId="3285713202" sldId="256"/>
            <ac:spMk id="13" creationId="{8E5D7A2D-05C1-A61D-BFED-7C69D3434A1F}"/>
          </ac:spMkLst>
        </pc:spChg>
        <pc:spChg chg="add mod">
          <ac:chgData name="辰巳　めぐみ" userId="88b1893c-db63-4bb5-9dca-a6ce3447aab8" providerId="ADAL" clId="{4C98BF49-9253-44F8-8335-0E5DA0562794}" dt="2025-12-16T07:18:38.371" v="123"/>
          <ac:spMkLst>
            <pc:docMk/>
            <pc:sldMk cId="3285713202" sldId="256"/>
            <ac:spMk id="14" creationId="{A742E53F-6316-2A3B-8BA1-8509558A026D}"/>
          </ac:spMkLst>
        </pc:spChg>
        <pc:spChg chg="add mod">
          <ac:chgData name="辰巳　めぐみ" userId="88b1893c-db63-4bb5-9dca-a6ce3447aab8" providerId="ADAL" clId="{4C98BF49-9253-44F8-8335-0E5DA0562794}" dt="2025-12-16T07:18:38.371" v="123"/>
          <ac:spMkLst>
            <pc:docMk/>
            <pc:sldMk cId="3285713202" sldId="256"/>
            <ac:spMk id="15" creationId="{7358E2A9-B43D-A60A-9D57-081EF5A97A10}"/>
          </ac:spMkLst>
        </pc:spChg>
        <pc:picChg chg="add mod">
          <ac:chgData name="辰巳　めぐみ" userId="88b1893c-db63-4bb5-9dca-a6ce3447aab8" providerId="ADAL" clId="{4C98BF49-9253-44F8-8335-0E5DA0562794}" dt="2025-12-16T07:05:40.116" v="120" actId="1076"/>
          <ac:picMkLst>
            <pc:docMk/>
            <pc:sldMk cId="3285713202" sldId="256"/>
            <ac:picMk id="7" creationId="{56D9B7DD-6BC4-3C4B-8BF9-DCEEB234762C}"/>
          </ac:picMkLst>
        </pc:picChg>
        <pc:picChg chg="add mod">
          <ac:chgData name="辰巳　めぐみ" userId="88b1893c-db63-4bb5-9dca-a6ce3447aab8" providerId="ADAL" clId="{4C98BF49-9253-44F8-8335-0E5DA0562794}" dt="2025-12-16T07:05:44.240" v="121" actId="1076"/>
          <ac:picMkLst>
            <pc:docMk/>
            <pc:sldMk cId="3285713202" sldId="256"/>
            <ac:picMk id="10" creationId="{1BDF38BC-EC21-F00A-DF51-C490E73EFAD4}"/>
          </ac:picMkLst>
        </pc:picChg>
        <pc:picChg chg="add mod">
          <ac:chgData name="辰巳　めぐみ" userId="88b1893c-db63-4bb5-9dca-a6ce3447aab8" providerId="ADAL" clId="{4C98BF49-9253-44F8-8335-0E5DA0562794}" dt="2025-12-16T07:05:50.636" v="122" actId="1076"/>
          <ac:picMkLst>
            <pc:docMk/>
            <pc:sldMk cId="3285713202" sldId="256"/>
            <ac:picMk id="12" creationId="{8ADC6EA6-75CE-8857-8880-48AD3BE5D77C}"/>
          </ac:picMkLst>
        </pc:picChg>
      </pc:sldChg>
    </pc:docChg>
  </pc:docChgLst>
  <pc:docChgLst>
    <pc:chgData name="服部功太郎" userId="dfa90986-4f25-4497-b3b8-2fd013cf44ca" providerId="ADAL" clId="{3F392336-E96B-403C-95D5-E382C60C12F1}"/>
    <pc:docChg chg="modSld">
      <pc:chgData name="服部功太郎" userId="dfa90986-4f25-4497-b3b8-2fd013cf44ca" providerId="ADAL" clId="{3F392336-E96B-403C-95D5-E382C60C12F1}" dt="2025-12-24T07:28:53.471" v="7" actId="20577"/>
      <pc:docMkLst>
        <pc:docMk/>
      </pc:docMkLst>
      <pc:sldChg chg="modSp mod">
        <pc:chgData name="服部功太郎" userId="dfa90986-4f25-4497-b3b8-2fd013cf44ca" providerId="ADAL" clId="{3F392336-E96B-403C-95D5-E382C60C12F1}" dt="2025-12-24T07:28:53.471" v="7" actId="20577"/>
        <pc:sldMkLst>
          <pc:docMk/>
          <pc:sldMk cId="3285713202" sldId="256"/>
        </pc:sldMkLst>
        <pc:spChg chg="mod">
          <ac:chgData name="服部功太郎" userId="dfa90986-4f25-4497-b3b8-2fd013cf44ca" providerId="ADAL" clId="{3F392336-E96B-403C-95D5-E382C60C12F1}" dt="2025-12-24T07:28:53.471" v="7" actId="20577"/>
          <ac:spMkLst>
            <pc:docMk/>
            <pc:sldMk cId="3285713202" sldId="256"/>
            <ac:spMk id="5" creationId="{131A1956-03FD-E9AD-3AD1-02E5585409F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83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222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442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824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65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631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926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250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1329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985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620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979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31A1956-03FD-E9AD-3AD1-02E5585409FB}"/>
              </a:ext>
            </a:extLst>
          </p:cNvPr>
          <p:cNvSpPr txBox="1"/>
          <p:nvPr/>
        </p:nvSpPr>
        <p:spPr>
          <a:xfrm>
            <a:off x="1144945" y="4606048"/>
            <a:ext cx="685410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altLang="ja-JP" sz="1400" b="1" dirty="0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5.</a:t>
            </a:r>
            <a:r>
              <a:rPr lang="en-US" altLang="ja-JP" sz="1400" dirty="0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mpact of collection tubes on CSF and plasma proteomes analyzed by volcano plots.</a:t>
            </a:r>
            <a:endParaRPr lang="ja-JP" altLang="ja-JP" sz="1400" dirty="0">
              <a:effectLst/>
              <a:latin typeface="Times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56D9B7DD-6BC4-3C4B-8BF9-DCEEB234762C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85549" y="1252489"/>
            <a:ext cx="2628000" cy="2628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1BDF38BC-EC21-F00A-DF51-C490E73EFAD4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55346" y="1252489"/>
            <a:ext cx="2628000" cy="262800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8ADC6EA6-75CE-8857-8880-48AD3BE5D77C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6030451" y="1252489"/>
            <a:ext cx="2628000" cy="2628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C121DDB-C507-4F57-DFDC-08DC60C2462F}"/>
              </a:ext>
            </a:extLst>
          </p:cNvPr>
          <p:cNvSpPr txBox="1"/>
          <p:nvPr/>
        </p:nvSpPr>
        <p:spPr>
          <a:xfrm>
            <a:off x="485549" y="103614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B594275-5190-B4B8-A37A-E6394FAAD666}"/>
              </a:ext>
            </a:extLst>
          </p:cNvPr>
          <p:cNvSpPr txBox="1"/>
          <p:nvPr/>
        </p:nvSpPr>
        <p:spPr>
          <a:xfrm>
            <a:off x="3255346" y="103338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8340E8A-1173-F224-D5F1-4EE301DBD3A2}"/>
              </a:ext>
            </a:extLst>
          </p:cNvPr>
          <p:cNvSpPr txBox="1"/>
          <p:nvPr/>
        </p:nvSpPr>
        <p:spPr>
          <a:xfrm>
            <a:off x="6025143" y="103337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35520D5-DABE-AB48-9A60-07C6A65DA240}"/>
              </a:ext>
            </a:extLst>
          </p:cNvPr>
          <p:cNvSpPr txBox="1"/>
          <p:nvPr/>
        </p:nvSpPr>
        <p:spPr>
          <a:xfrm>
            <a:off x="1189131" y="3828131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896ECC6-4160-58EE-9664-2E6403709359}"/>
              </a:ext>
            </a:extLst>
          </p:cNvPr>
          <p:cNvSpPr txBox="1"/>
          <p:nvPr/>
        </p:nvSpPr>
        <p:spPr>
          <a:xfrm>
            <a:off x="3965844" y="3828131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06A334C-27D0-4C56-C285-18677DA4DE9F}"/>
              </a:ext>
            </a:extLst>
          </p:cNvPr>
          <p:cNvSpPr txBox="1"/>
          <p:nvPr/>
        </p:nvSpPr>
        <p:spPr>
          <a:xfrm>
            <a:off x="6742557" y="3824046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E5D7A2D-05C1-A61D-BFED-7C69D3434A1F}"/>
              </a:ext>
            </a:extLst>
          </p:cNvPr>
          <p:cNvSpPr txBox="1"/>
          <p:nvPr/>
        </p:nvSpPr>
        <p:spPr>
          <a:xfrm rot="16200000">
            <a:off x="-178382" y="2368361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742E53F-6316-2A3B-8BA1-8509558A026D}"/>
              </a:ext>
            </a:extLst>
          </p:cNvPr>
          <p:cNvSpPr txBox="1"/>
          <p:nvPr/>
        </p:nvSpPr>
        <p:spPr>
          <a:xfrm rot="16200000">
            <a:off x="2606551" y="2368361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358E2A9-B43D-A60A-9D57-081EF5A97A10}"/>
              </a:ext>
            </a:extLst>
          </p:cNvPr>
          <p:cNvSpPr txBox="1"/>
          <p:nvPr/>
        </p:nvSpPr>
        <p:spPr>
          <a:xfrm rot="16200000">
            <a:off x="5420455" y="2368361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571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4E485A41FBE0840AEF03DC6126CF7E9" ma:contentTypeVersion="10" ma:contentTypeDescription="新しいドキュメントを作成します。" ma:contentTypeScope="" ma:versionID="b7fc72b48302197a3c00e12c5a71d0f2">
  <xsd:schema xmlns:xsd="http://www.w3.org/2001/XMLSchema" xmlns:xs="http://www.w3.org/2001/XMLSchema" xmlns:p="http://schemas.microsoft.com/office/2006/metadata/properties" xmlns:ns2="09e658bc-5f5e-48b2-a593-8f2a4dff4e86" targetNamespace="http://schemas.microsoft.com/office/2006/metadata/properties" ma:root="true" ma:fieldsID="3811df9a92dabbc9fbde200746e96434" ns2:_="">
    <xsd:import namespace="09e658bc-5f5e-48b2-a593-8f2a4dff4e8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e658bc-5f5e-48b2-a593-8f2a4dff4e8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画像タグ" ma:readOnly="false" ma:fieldId="{5cf76f15-5ced-4ddc-b409-7134ff3c332f}" ma:taxonomyMulti="true" ma:sspId="559d5a2e-65d4-4456-94da-aa20a3af47a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9e658bc-5f5e-48b2-a593-8f2a4dff4e86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967A98E4-4128-4D53-BA5A-A0CF6C5D641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EEE3FE6-872E-4DDC-BEB3-544C48060B07}"/>
</file>

<file path=customXml/itemProps3.xml><?xml version="1.0" encoding="utf-8"?>
<ds:datastoreItem xmlns:ds="http://schemas.openxmlformats.org/officeDocument/2006/customXml" ds:itemID="{D6E8AD14-6D02-4DC1-A6B6-1EC96F94028C}">
  <ds:schemaRefs>
    <ds:schemaRef ds:uri="http://schemas.microsoft.com/office/2006/metadata/properties"/>
    <ds:schemaRef ds:uri="http://www.w3.org/XML/1998/namespace"/>
    <ds:schemaRef ds:uri="http://purl.org/dc/dcmitype/"/>
    <ds:schemaRef ds:uri="http://schemas.openxmlformats.org/package/2006/metadata/core-properties"/>
    <ds:schemaRef ds:uri="http://schemas.microsoft.com/office/2006/documentManagement/types"/>
    <ds:schemaRef ds:uri="http://purl.org/dc/terms/"/>
    <ds:schemaRef ds:uri="http://schemas.microsoft.com/office/infopath/2007/PartnerControls"/>
    <ds:schemaRef ds:uri="http://purl.org/dc/elements/1.1/"/>
    <ds:schemaRef ds:uri="09e658bc-5f5e-48b2-a593-8f2a4dff4e86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1</TotalTime>
  <Words>38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辰巳　めぐみ</dc:creator>
  <cp:lastModifiedBy>辰巳　めぐみ</cp:lastModifiedBy>
  <cp:revision>5</cp:revision>
  <dcterms:created xsi:type="dcterms:W3CDTF">2025-03-28T03:13:18Z</dcterms:created>
  <dcterms:modified xsi:type="dcterms:W3CDTF">2026-03-31T07:57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4E485A41FBE0840AEF03DC6126CF7E9</vt:lpwstr>
  </property>
  <property fmtid="{D5CDD505-2E9C-101B-9397-08002B2CF9AE}" pid="3" name="MediaServiceImageTags">
    <vt:lpwstr/>
  </property>
</Properties>
</file>